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3" autoAdjust="0"/>
    <p:restoredTop sz="94660"/>
  </p:normalViewPr>
  <p:slideViewPr>
    <p:cSldViewPr snapToGrid="0">
      <p:cViewPr varScale="1">
        <p:scale>
          <a:sx n="66" d="100"/>
          <a:sy n="66" d="100"/>
        </p:scale>
        <p:origin x="40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C4DF32-D8CA-4AE9-8369-676EBA649BE1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3CADA2-D913-43B2-AD48-3847F9E26B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371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309073-3A60-4996-A87C-77180038F61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098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613AC-D2DE-F0CD-7DA5-BE0F184B3D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5425FF-0770-09F0-AEA8-F4B650641C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437444-8FD3-7FA5-74F8-CBF8D36ED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20F895-93B9-F264-AAF9-88F9A224C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C6E7AC-E690-A81B-1C13-E8E3F81E6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760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600D5B-B2C4-AC54-1CA1-D6DDD96E43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903E7D-9E01-4971-BB93-3399BCA63C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782A42-C9DD-DCFB-B57A-393D320B1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003186-1A77-549D-4C7B-7D9952723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CEDF16-7D0C-4256-F0FC-26134CBA2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064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31D09A-BBD4-F3EE-5076-01B5A93763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BAF755-7384-9220-C7BC-3362459682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82B938-1CBB-53FA-EF49-7A86F9E4C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BD21F9-9FFD-E81E-36DD-EE8F035BF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7C3C49-48AE-124A-A964-1AC1412FA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252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CB9BE-88AE-1762-3B34-952FEE531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95B8BE-2A90-1710-6D04-602538448B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0434EE-186B-90A0-7988-5598D323A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765179-64E9-06D4-36C8-27B84FA86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A4F2AB-9AAA-3EA1-B1AF-BDECADCA0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47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1C1DC5-4EB2-D357-3F9B-65816F6837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A04387-52BF-D256-CA9D-4E58E54411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146919-AD76-E128-E232-5EB966A49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E0AFF4-B7D3-837C-B0EC-1F97972C8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DE661-AC73-FC32-4F4A-64E9D8565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415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126CE9-5386-1927-EA76-6E5EB6539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076679-60E6-23A9-4460-80DB3C4F38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676998-A5F6-A088-00AE-6E3DCE7A23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77B1B8-5895-6EED-5728-D096B7FFA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682853-609E-E765-8643-AF00763DA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061A23-55BF-DA06-0928-2341A4A5E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98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EE7F6-3A37-A385-B589-B1CE93E04E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6AD10A-A279-FB3E-1AD1-8C36807032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7FFA37-40FB-E94E-B44B-186A8552BB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46E61A-7107-B302-4A2E-CF68EE31DB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244867-4764-3858-3646-C95AF8663D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29E4C8-33EC-0671-AE98-C883F1485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E0F346-42B0-B28C-0093-9DA16264E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604F375-A503-00FA-DF20-931C1E357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732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AFCBCF-1C1A-3E97-0C0D-923453DF3D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714E325-CAD3-1E67-36EE-64087E144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DE0C29-9421-35E2-7DFF-19E9E513B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8A648A-E9F6-CBDC-A397-76888A5B5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25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E9CEED-5B29-3B19-E972-0893A4FFA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BA5EE5-181C-F36E-0B42-118E6249C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2603C7-E83B-3CEE-397C-224090D14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210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1316C-6B3D-3907-F051-78CF8EEA7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60A790-1666-22E6-0907-E8275765E0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651F8E-84DC-1D2D-1C8A-B3FF3185D2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0E269D-5ACB-40EF-6D40-168372165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E37480-491F-542F-7608-449F143BB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ACEA94-2D64-2671-2AFF-38A18591F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170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D7498B-D549-8DEE-4F14-97D50DE95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27E4B6-D054-A06B-ABAB-21C05A7026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B07CD4-7875-9C1A-0E5A-2E8EB0B5F4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E29ED6-20AF-4439-0428-F1A0571AC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481CE2-8945-7A30-7952-BF02087650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07CE8C-FB19-338D-2BA1-62FBDAFF1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822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F00661-A327-7C59-61B3-BCD17B1FB5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AF6F20-0336-17F8-78AC-FE3B13D14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BC1730-F2A8-8A7F-AD87-BA9F8C9E5F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71AEF-6A55-40B6-96F1-F5C5B86006A4}" type="datetimeFigureOut">
              <a:rPr lang="en-US" smtClean="0"/>
              <a:t>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D3839D-0826-21ED-8672-576B766791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5615C0-DD05-EBA9-CDB5-845F478CD9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2B581-F175-4338-8913-C60B6A2B1E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234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een lines on a black background&#10;&#10;Description automatically generated">
            <a:extLst>
              <a:ext uri="{FF2B5EF4-FFF2-40B4-BE49-F238E27FC236}">
                <a16:creationId xmlns:a16="http://schemas.microsoft.com/office/drawing/2014/main" id="{DA2BD5F2-2B2B-9E3B-83F6-B896609EED8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382" t="-1000" r="-95" b="701"/>
          <a:stretch/>
        </p:blipFill>
        <p:spPr>
          <a:xfrm>
            <a:off x="795130" y="968827"/>
            <a:ext cx="5180106" cy="2658972"/>
          </a:xfrm>
          <a:prstGeom prst="rect">
            <a:avLst/>
          </a:prstGeom>
        </p:spPr>
      </p:pic>
      <p:pic>
        <p:nvPicPr>
          <p:cNvPr id="7" name="Picture 6" descr="A red line on a black background&#10;&#10;Description automatically generated">
            <a:extLst>
              <a:ext uri="{FF2B5EF4-FFF2-40B4-BE49-F238E27FC236}">
                <a16:creationId xmlns:a16="http://schemas.microsoft.com/office/drawing/2014/main" id="{F6FEBFD7-227D-A581-6F11-19248FAE736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87" t="-1971" r="7888" b="-2253"/>
          <a:stretch/>
        </p:blipFill>
        <p:spPr>
          <a:xfrm>
            <a:off x="782741" y="4035646"/>
            <a:ext cx="5180106" cy="2763078"/>
          </a:xfrm>
          <a:prstGeom prst="rect">
            <a:avLst/>
          </a:prstGeom>
        </p:spPr>
      </p:pic>
      <p:pic>
        <p:nvPicPr>
          <p:cNvPr id="35" name="Picture 34" descr="A green and red light&#10;&#10;Description automatically generated">
            <a:extLst>
              <a:ext uri="{FF2B5EF4-FFF2-40B4-BE49-F238E27FC236}">
                <a16:creationId xmlns:a16="http://schemas.microsoft.com/office/drawing/2014/main" id="{0911A83D-7868-DE09-4618-A48C9384981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567" t="17565" r="2152" b="6185"/>
          <a:stretch/>
        </p:blipFill>
        <p:spPr>
          <a:xfrm>
            <a:off x="6612673" y="996436"/>
            <a:ext cx="5364943" cy="361784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A373CB7-2FF8-D1CB-B95F-2AA64B670E00}"/>
              </a:ext>
            </a:extLst>
          </p:cNvPr>
          <p:cNvSpPr txBox="1"/>
          <p:nvPr/>
        </p:nvSpPr>
        <p:spPr>
          <a:xfrm>
            <a:off x="5470352" y="1902735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7C3059-0ABB-2042-980B-D21E0FD053C5}"/>
              </a:ext>
            </a:extLst>
          </p:cNvPr>
          <p:cNvSpPr txBox="1"/>
          <p:nvPr/>
        </p:nvSpPr>
        <p:spPr>
          <a:xfrm>
            <a:off x="5470352" y="2167292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B99AA59-B2D2-78D5-938C-265BCA99FCE7}"/>
              </a:ext>
            </a:extLst>
          </p:cNvPr>
          <p:cNvSpPr txBox="1"/>
          <p:nvPr/>
        </p:nvSpPr>
        <p:spPr>
          <a:xfrm>
            <a:off x="5470352" y="2483105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4D41670-B338-3B10-4843-606FE98D8257}"/>
              </a:ext>
            </a:extLst>
          </p:cNvPr>
          <p:cNvSpPr txBox="1"/>
          <p:nvPr/>
        </p:nvSpPr>
        <p:spPr>
          <a:xfrm>
            <a:off x="5470352" y="1619382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kD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6F44BB36-4DEB-AA02-971E-B069F95FF0F9}"/>
              </a:ext>
            </a:extLst>
          </p:cNvPr>
          <p:cNvCxnSpPr/>
          <p:nvPr/>
        </p:nvCxnSpPr>
        <p:spPr>
          <a:xfrm>
            <a:off x="5133818" y="1797128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58FF62B0-F90B-9AEA-C97B-5014A93E98A7}"/>
              </a:ext>
            </a:extLst>
          </p:cNvPr>
          <p:cNvCxnSpPr/>
          <p:nvPr/>
        </p:nvCxnSpPr>
        <p:spPr>
          <a:xfrm>
            <a:off x="5133818" y="2063828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336AEA1-E7BD-B422-BBC3-A56EFF5E735F}"/>
              </a:ext>
            </a:extLst>
          </p:cNvPr>
          <p:cNvCxnSpPr/>
          <p:nvPr/>
        </p:nvCxnSpPr>
        <p:spPr>
          <a:xfrm>
            <a:off x="5133818" y="2292428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589393B-A74E-960C-FD83-A157A0B9CF38}"/>
              </a:ext>
            </a:extLst>
          </p:cNvPr>
          <p:cNvCxnSpPr/>
          <p:nvPr/>
        </p:nvCxnSpPr>
        <p:spPr>
          <a:xfrm>
            <a:off x="5133818" y="2616278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77F4E2C1-BE9F-4571-6A87-78775E46D3D4}"/>
              </a:ext>
            </a:extLst>
          </p:cNvPr>
          <p:cNvSpPr txBox="1"/>
          <p:nvPr/>
        </p:nvSpPr>
        <p:spPr>
          <a:xfrm rot="19366315">
            <a:off x="2156597" y="637219"/>
            <a:ext cx="566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C798A77-F2BC-CA35-0C1F-A77ECE455482}"/>
              </a:ext>
            </a:extLst>
          </p:cNvPr>
          <p:cNvSpPr txBox="1"/>
          <p:nvPr/>
        </p:nvSpPr>
        <p:spPr>
          <a:xfrm rot="19366315">
            <a:off x="2487762" y="522592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169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81294E6-EE6A-BEE5-D5E9-AEB6BFE0DD60}"/>
              </a:ext>
            </a:extLst>
          </p:cNvPr>
          <p:cNvSpPr txBox="1"/>
          <p:nvPr/>
        </p:nvSpPr>
        <p:spPr>
          <a:xfrm rot="19366315">
            <a:off x="2966302" y="496437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170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272339-14FF-EF35-7EC0-E273AAF94460}"/>
              </a:ext>
            </a:extLst>
          </p:cNvPr>
          <p:cNvSpPr txBox="1"/>
          <p:nvPr/>
        </p:nvSpPr>
        <p:spPr>
          <a:xfrm rot="19366315">
            <a:off x="3366165" y="480461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378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87EA772-82A1-2019-F880-CFB3A3D5514B}"/>
              </a:ext>
            </a:extLst>
          </p:cNvPr>
          <p:cNvSpPr txBox="1"/>
          <p:nvPr/>
        </p:nvSpPr>
        <p:spPr>
          <a:xfrm rot="19366315">
            <a:off x="3822314" y="483891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386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AE9A1F7-379B-9E0A-238A-BAEE5196C64B}"/>
              </a:ext>
            </a:extLst>
          </p:cNvPr>
          <p:cNvSpPr txBox="1"/>
          <p:nvPr/>
        </p:nvSpPr>
        <p:spPr>
          <a:xfrm rot="19366315">
            <a:off x="4229475" y="471344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431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3524AE4-BD36-B9F3-414C-A721C8AEDC49}"/>
              </a:ext>
            </a:extLst>
          </p:cNvPr>
          <p:cNvSpPr txBox="1"/>
          <p:nvPr/>
        </p:nvSpPr>
        <p:spPr>
          <a:xfrm rot="19366315">
            <a:off x="4629338" y="494912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434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75D78B0-F977-1898-C066-26D1CA5DDDAC}"/>
              </a:ext>
            </a:extLst>
          </p:cNvPr>
          <p:cNvSpPr txBox="1"/>
          <p:nvPr/>
        </p:nvSpPr>
        <p:spPr>
          <a:xfrm rot="19366315">
            <a:off x="1145065" y="558879"/>
            <a:ext cx="8589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cDN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BCF625-78F1-61DA-2420-C953C86C3DDC}"/>
              </a:ext>
            </a:extLst>
          </p:cNvPr>
          <p:cNvSpPr txBox="1"/>
          <p:nvPr/>
        </p:nvSpPr>
        <p:spPr>
          <a:xfrm rot="19366315">
            <a:off x="1623606" y="543183"/>
            <a:ext cx="8589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cDN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C7FCA21-566C-A845-D7FF-DDCBA1294195}"/>
              </a:ext>
            </a:extLst>
          </p:cNvPr>
          <p:cNvCxnSpPr/>
          <p:nvPr/>
        </p:nvCxnSpPr>
        <p:spPr>
          <a:xfrm>
            <a:off x="1900284" y="337136"/>
            <a:ext cx="330470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12A6BA87-0B82-6517-43C6-0166BB61F867}"/>
              </a:ext>
            </a:extLst>
          </p:cNvPr>
          <p:cNvSpPr txBox="1"/>
          <p:nvPr/>
        </p:nvSpPr>
        <p:spPr>
          <a:xfrm>
            <a:off x="2735356" y="-9604"/>
            <a:ext cx="1841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99-720 (FLAG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E56E87D-2774-E23D-B7F4-4883D34C2449}"/>
              </a:ext>
            </a:extLst>
          </p:cNvPr>
          <p:cNvSpPr txBox="1"/>
          <p:nvPr/>
        </p:nvSpPr>
        <p:spPr>
          <a:xfrm>
            <a:off x="2631748" y="3259723"/>
            <a:ext cx="1841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B: FLA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5AD4DF7-C164-D1F6-D870-E32614017B14}"/>
              </a:ext>
            </a:extLst>
          </p:cNvPr>
          <p:cNvSpPr txBox="1"/>
          <p:nvPr/>
        </p:nvSpPr>
        <p:spPr>
          <a:xfrm>
            <a:off x="5903429" y="5181798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9AF2FF1-712A-DB0E-8880-7B260B5949FA}"/>
              </a:ext>
            </a:extLst>
          </p:cNvPr>
          <p:cNvSpPr txBox="1"/>
          <p:nvPr/>
        </p:nvSpPr>
        <p:spPr>
          <a:xfrm>
            <a:off x="5903429" y="4930842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14427C8-7FDE-C1B6-7734-F7B932402B9E}"/>
              </a:ext>
            </a:extLst>
          </p:cNvPr>
          <p:cNvSpPr txBox="1"/>
          <p:nvPr/>
        </p:nvSpPr>
        <p:spPr>
          <a:xfrm>
            <a:off x="5903429" y="5528555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D0DFB08-A506-EB34-6E97-7AC6D7F514E8}"/>
              </a:ext>
            </a:extLst>
          </p:cNvPr>
          <p:cNvCxnSpPr/>
          <p:nvPr/>
        </p:nvCxnSpPr>
        <p:spPr>
          <a:xfrm>
            <a:off x="5618700" y="5135258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D15DF99-2E7E-5667-600A-32E504128C61}"/>
              </a:ext>
            </a:extLst>
          </p:cNvPr>
          <p:cNvCxnSpPr/>
          <p:nvPr/>
        </p:nvCxnSpPr>
        <p:spPr>
          <a:xfrm>
            <a:off x="5627768" y="5405376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8B75279D-094A-83DF-7D11-58E47940CA2B}"/>
              </a:ext>
            </a:extLst>
          </p:cNvPr>
          <p:cNvCxnSpPr/>
          <p:nvPr/>
        </p:nvCxnSpPr>
        <p:spPr>
          <a:xfrm>
            <a:off x="5624525" y="5723147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4AE9E6BF-045F-6480-4645-B54ABC501381}"/>
              </a:ext>
            </a:extLst>
          </p:cNvPr>
          <p:cNvSpPr txBox="1"/>
          <p:nvPr/>
        </p:nvSpPr>
        <p:spPr>
          <a:xfrm>
            <a:off x="2479244" y="6373999"/>
            <a:ext cx="1841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B: GAPDH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89E3CCA-DCC5-A01E-03E2-69F3EECA1C4E}"/>
              </a:ext>
            </a:extLst>
          </p:cNvPr>
          <p:cNvSpPr txBox="1"/>
          <p:nvPr/>
        </p:nvSpPr>
        <p:spPr>
          <a:xfrm rot="19366315">
            <a:off x="7951890" y="625720"/>
            <a:ext cx="566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AA90CB7-A255-23E5-13AC-2ED9A6458B5D}"/>
              </a:ext>
            </a:extLst>
          </p:cNvPr>
          <p:cNvSpPr txBox="1"/>
          <p:nvPr/>
        </p:nvSpPr>
        <p:spPr>
          <a:xfrm rot="19366315">
            <a:off x="8283055" y="511093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169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64599C0-BC43-DEA3-8A6A-B55DE79EE69F}"/>
              </a:ext>
            </a:extLst>
          </p:cNvPr>
          <p:cNvSpPr txBox="1"/>
          <p:nvPr/>
        </p:nvSpPr>
        <p:spPr>
          <a:xfrm rot="19366315">
            <a:off x="8761595" y="484938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170F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B4D19B2-A618-C546-E57F-BECA6C260FD9}"/>
              </a:ext>
            </a:extLst>
          </p:cNvPr>
          <p:cNvSpPr txBox="1"/>
          <p:nvPr/>
        </p:nvSpPr>
        <p:spPr>
          <a:xfrm rot="19366315">
            <a:off x="9161458" y="468962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378E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74F7A62-A1CF-40DF-2A36-77E5478EF3C8}"/>
              </a:ext>
            </a:extLst>
          </p:cNvPr>
          <p:cNvSpPr txBox="1"/>
          <p:nvPr/>
        </p:nvSpPr>
        <p:spPr>
          <a:xfrm rot="19366315">
            <a:off x="9617607" y="472392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386S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95B5DA7-05B8-0466-BA13-A29C48C2FA08}"/>
              </a:ext>
            </a:extLst>
          </p:cNvPr>
          <p:cNvSpPr txBox="1"/>
          <p:nvPr/>
        </p:nvSpPr>
        <p:spPr>
          <a:xfrm rot="19366315">
            <a:off x="10024768" y="459845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431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8F6CC55-7FF3-2368-32E3-5543DD295070}"/>
              </a:ext>
            </a:extLst>
          </p:cNvPr>
          <p:cNvSpPr txBox="1"/>
          <p:nvPr/>
        </p:nvSpPr>
        <p:spPr>
          <a:xfrm rot="19366315">
            <a:off x="10424631" y="483413"/>
            <a:ext cx="9788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434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7AE119C-8E9A-3FF8-D099-8C69C9D9C9C8}"/>
              </a:ext>
            </a:extLst>
          </p:cNvPr>
          <p:cNvSpPr txBox="1"/>
          <p:nvPr/>
        </p:nvSpPr>
        <p:spPr>
          <a:xfrm rot="19366315">
            <a:off x="6940358" y="547380"/>
            <a:ext cx="8589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cDN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E807B36-80AD-4662-67F8-D62E9DA5BE06}"/>
              </a:ext>
            </a:extLst>
          </p:cNvPr>
          <p:cNvSpPr txBox="1"/>
          <p:nvPr/>
        </p:nvSpPr>
        <p:spPr>
          <a:xfrm rot="19366315">
            <a:off x="7418899" y="531684"/>
            <a:ext cx="8589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cDN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8C6AA271-7E8F-7311-37BC-82FAA7B5FB6F}"/>
              </a:ext>
            </a:extLst>
          </p:cNvPr>
          <p:cNvCxnSpPr/>
          <p:nvPr/>
        </p:nvCxnSpPr>
        <p:spPr>
          <a:xfrm>
            <a:off x="7695577" y="325637"/>
            <a:ext cx="330470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655015AA-C3E3-0B31-1A59-25758059F500}"/>
              </a:ext>
            </a:extLst>
          </p:cNvPr>
          <p:cNvSpPr txBox="1"/>
          <p:nvPr/>
        </p:nvSpPr>
        <p:spPr>
          <a:xfrm>
            <a:off x="8530649" y="-21103"/>
            <a:ext cx="1841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99-720 (FLAG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34CEE73-91A2-8B54-4623-5EE656284E32}"/>
              </a:ext>
            </a:extLst>
          </p:cNvPr>
          <p:cNvSpPr txBox="1"/>
          <p:nvPr/>
        </p:nvSpPr>
        <p:spPr>
          <a:xfrm>
            <a:off x="11233181" y="2175328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54CD0E8-F4EF-1344-6F0E-FC4E35F0E02A}"/>
              </a:ext>
            </a:extLst>
          </p:cNvPr>
          <p:cNvSpPr txBox="1"/>
          <p:nvPr/>
        </p:nvSpPr>
        <p:spPr>
          <a:xfrm>
            <a:off x="11233181" y="2439885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E8B0D91-EDF2-DCD0-6AB4-D1816BD67624}"/>
              </a:ext>
            </a:extLst>
          </p:cNvPr>
          <p:cNvSpPr txBox="1"/>
          <p:nvPr/>
        </p:nvSpPr>
        <p:spPr>
          <a:xfrm>
            <a:off x="11233181" y="2755698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486A7C81-B982-BDEA-662B-28E2D56BED32}"/>
              </a:ext>
            </a:extLst>
          </p:cNvPr>
          <p:cNvCxnSpPr/>
          <p:nvPr/>
        </p:nvCxnSpPr>
        <p:spPr>
          <a:xfrm>
            <a:off x="10896647" y="3704881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9687DD76-A330-70C8-7CDE-9FDD43BE87A0}"/>
              </a:ext>
            </a:extLst>
          </p:cNvPr>
          <p:cNvCxnSpPr/>
          <p:nvPr/>
        </p:nvCxnSpPr>
        <p:spPr>
          <a:xfrm>
            <a:off x="10896647" y="2344661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17F6E337-B9CB-FE08-ED6C-ACCE1288977C}"/>
              </a:ext>
            </a:extLst>
          </p:cNvPr>
          <p:cNvCxnSpPr/>
          <p:nvPr/>
        </p:nvCxnSpPr>
        <p:spPr>
          <a:xfrm>
            <a:off x="10896647" y="2573261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61DD4DEA-993D-3FFE-B007-75F401F43543}"/>
              </a:ext>
            </a:extLst>
          </p:cNvPr>
          <p:cNvCxnSpPr/>
          <p:nvPr/>
        </p:nvCxnSpPr>
        <p:spPr>
          <a:xfrm>
            <a:off x="10896647" y="2897111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8C368B2-DF20-392B-0D3B-1B39F8242FFB}"/>
              </a:ext>
            </a:extLst>
          </p:cNvPr>
          <p:cNvCxnSpPr/>
          <p:nvPr/>
        </p:nvCxnSpPr>
        <p:spPr>
          <a:xfrm>
            <a:off x="10894669" y="3346644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7236430E-E9D8-1C58-643F-AB34BDC99075}"/>
              </a:ext>
            </a:extLst>
          </p:cNvPr>
          <p:cNvSpPr txBox="1"/>
          <p:nvPr/>
        </p:nvSpPr>
        <p:spPr>
          <a:xfrm>
            <a:off x="11231203" y="3181230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BBFD8A5-8F44-E951-D91E-5AD9C5A04063}"/>
              </a:ext>
            </a:extLst>
          </p:cNvPr>
          <p:cNvSpPr txBox="1"/>
          <p:nvPr/>
        </p:nvSpPr>
        <p:spPr>
          <a:xfrm>
            <a:off x="11243078" y="3537490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427F662-AB6E-4500-0250-BFD8A2DA21DD}"/>
              </a:ext>
            </a:extLst>
          </p:cNvPr>
          <p:cNvCxnSpPr/>
          <p:nvPr/>
        </p:nvCxnSpPr>
        <p:spPr>
          <a:xfrm>
            <a:off x="10859846" y="2063828"/>
            <a:ext cx="27432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F964BE56-6B63-798A-A2AA-F87A4A907061}"/>
              </a:ext>
            </a:extLst>
          </p:cNvPr>
          <p:cNvSpPr txBox="1"/>
          <p:nvPr/>
        </p:nvSpPr>
        <p:spPr>
          <a:xfrm>
            <a:off x="11168989" y="1888594"/>
            <a:ext cx="7464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kD</a:t>
            </a:r>
          </a:p>
        </p:txBody>
      </p:sp>
    </p:spTree>
    <p:extLst>
      <p:ext uri="{BB962C8B-B14F-4D97-AF65-F5344CB8AC3E}">
        <p14:creationId xmlns:p14="http://schemas.microsoft.com/office/powerpoint/2010/main" val="675305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46</Words>
  <Application>Microsoft Office PowerPoint</Application>
  <PresentationFormat>Widescreen</PresentationFormat>
  <Paragraphs>3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esako, Masato,PhD</dc:creator>
  <cp:lastModifiedBy>Wolfe, Michael Scott</cp:lastModifiedBy>
  <cp:revision>11</cp:revision>
  <dcterms:created xsi:type="dcterms:W3CDTF">2024-11-12T19:05:17Z</dcterms:created>
  <dcterms:modified xsi:type="dcterms:W3CDTF">2025-02-10T19:18:12Z</dcterms:modified>
</cp:coreProperties>
</file>